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>
        <p:scale>
          <a:sx n="95" d="100"/>
          <a:sy n="95" d="100"/>
        </p:scale>
        <p:origin x="6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4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Serum sclerostin as a marker of microvascular and macrovascular complications among children and adolescents with type 1 diabetes mellitus</a:t>
            </a:r>
            <a:endParaRPr lang="en-US" sz="2400" dirty="0">
              <a:solidFill>
                <a:schemeClr val="bg1"/>
              </a:solidFill>
              <a:effectLst/>
              <a:latin typeface="+mn-lt"/>
              <a:ea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691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AIM</a:t>
            </a:r>
            <a:r>
              <a:rPr lang="en-GB" sz="1400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Assess serum sclerostin in T1DM and its association with diabetic angiopathies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65427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allam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Serum sclerostin may be linked to both DN and early atherosclerotic changes in T1DM patients, highlighting its potential as a valuable biomarker for evaluating diabetic angiopathies.</a:t>
            </a: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-----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541AC42-20A1-0DD5-28F3-C00DF9620578}"/>
              </a:ext>
            </a:extLst>
          </p:cNvPr>
          <p:cNvSpPr/>
          <p:nvPr/>
        </p:nvSpPr>
        <p:spPr>
          <a:xfrm>
            <a:off x="426245" y="4401075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Controls </a:t>
            </a:r>
          </a:p>
          <a:p>
            <a:pPr algn="ctr"/>
            <a:r>
              <a:rPr lang="en-GB" sz="2000" dirty="0"/>
              <a:t>(n = 25)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97AEB93-9105-4A3E-9F21-CD2484395E8E}"/>
              </a:ext>
            </a:extLst>
          </p:cNvPr>
          <p:cNvSpPr/>
          <p:nvPr/>
        </p:nvSpPr>
        <p:spPr>
          <a:xfrm>
            <a:off x="433173" y="2542539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DN </a:t>
            </a:r>
          </a:p>
          <a:p>
            <a:pPr algn="ctr"/>
            <a:r>
              <a:rPr lang="en-GB" sz="2000" dirty="0"/>
              <a:t>(n = 25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F3A94CD-8A6C-3CBA-6AA3-40DEE618D95B}"/>
              </a:ext>
            </a:extLst>
          </p:cNvPr>
          <p:cNvSpPr/>
          <p:nvPr/>
        </p:nvSpPr>
        <p:spPr>
          <a:xfrm>
            <a:off x="415591" y="3365551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Non-DN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(n = 25)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2970E2C-2F0D-1ED7-7F8C-F86977B72903}"/>
              </a:ext>
            </a:extLst>
          </p:cNvPr>
          <p:cNvCxnSpPr/>
          <p:nvPr/>
        </p:nvCxnSpPr>
        <p:spPr>
          <a:xfrm>
            <a:off x="2353430" y="3663403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932E31B7-1DB1-E5DC-A1F6-1741B3C71E7B}"/>
              </a:ext>
            </a:extLst>
          </p:cNvPr>
          <p:cNvCxnSpPr/>
          <p:nvPr/>
        </p:nvCxnSpPr>
        <p:spPr>
          <a:xfrm flipV="1">
            <a:off x="2353429" y="2979605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D28D4D9C-75B2-BDE2-E047-6FBE6F387B9E}"/>
              </a:ext>
            </a:extLst>
          </p:cNvPr>
          <p:cNvSpPr/>
          <p:nvPr/>
        </p:nvSpPr>
        <p:spPr>
          <a:xfrm>
            <a:off x="3205791" y="3377537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Serum </a:t>
            </a:r>
            <a:r>
              <a:rPr lang="en-US" dirty="0"/>
              <a:t>sclerostin </a:t>
            </a:r>
            <a:endParaRPr lang="en-GB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D3660C8-6F6A-35B6-4E39-6D5BC1E3DF8A}"/>
              </a:ext>
            </a:extLst>
          </p:cNvPr>
          <p:cNvSpPr/>
          <p:nvPr/>
        </p:nvSpPr>
        <p:spPr>
          <a:xfrm>
            <a:off x="3198863" y="4281388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IMT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6BC63038-5F33-B470-59F0-A7442D1CE2A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525" r="4614"/>
          <a:stretch/>
        </p:blipFill>
        <p:spPr>
          <a:xfrm>
            <a:off x="5143892" y="1890391"/>
            <a:ext cx="2228850" cy="164592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AC57F43-E002-08E6-B589-1BCBC97BD64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498" t="3966" r="2148"/>
          <a:stretch/>
        </p:blipFill>
        <p:spPr>
          <a:xfrm>
            <a:off x="5158165" y="3762162"/>
            <a:ext cx="2268712" cy="18288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0E19BE2-CF9F-A21C-5238-FB7EA9F452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70254" y="3656561"/>
            <a:ext cx="2536631" cy="2011680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3A09EEEB-808F-F34F-B82D-07383AF020B0}"/>
              </a:ext>
            </a:extLst>
          </p:cNvPr>
          <p:cNvSpPr/>
          <p:nvPr/>
        </p:nvSpPr>
        <p:spPr>
          <a:xfrm>
            <a:off x="3198863" y="2574578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linical</a:t>
            </a:r>
          </a:p>
        </p:txBody>
      </p:sp>
      <p:pic>
        <p:nvPicPr>
          <p:cNvPr id="1026" name="Picture 3" descr="Output image">
            <a:extLst>
              <a:ext uri="{FF2B5EF4-FFF2-40B4-BE49-F238E27FC236}">
                <a16:creationId xmlns:a16="http://schemas.microsoft.com/office/drawing/2014/main" id="{6C9981E5-3A32-18D7-BA0B-8F1E72D799E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1" b="4897"/>
          <a:stretch/>
        </p:blipFill>
        <p:spPr bwMode="auto">
          <a:xfrm>
            <a:off x="7986463" y="1669588"/>
            <a:ext cx="3021749" cy="1920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4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4-22T19:30:46Z</dcterms:modified>
</cp:coreProperties>
</file>